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320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447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585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75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34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298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631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339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183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533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997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443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1816" y="554253"/>
            <a:ext cx="2032000" cy="18288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47872" y="584733"/>
            <a:ext cx="1950720" cy="179832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127760" y="215401"/>
            <a:ext cx="530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.)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2084832" y="184921"/>
            <a:ext cx="2843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MUTZ-3 Unstained Controls</a:t>
            </a:r>
            <a:endParaRPr lang="en-US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80735" y="400067"/>
            <a:ext cx="6711265" cy="3994482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5520359" y="229634"/>
            <a:ext cx="530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r>
              <a:rPr lang="en-US" b="1" dirty="0" smtClean="0"/>
              <a:t>.)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1127760" y="2363864"/>
            <a:ext cx="530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  <a:r>
              <a:rPr lang="en-US" b="1" dirty="0" smtClean="0"/>
              <a:t>.)</a:t>
            </a:r>
            <a:endParaRPr lang="en-US" b="1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84039" y="2752385"/>
            <a:ext cx="1885714" cy="18000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45239" y="2752385"/>
            <a:ext cx="1895238" cy="183809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65661" y="4546662"/>
            <a:ext cx="2079578" cy="2033705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08482" y="4590480"/>
            <a:ext cx="2131995" cy="2022259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7769352" y="217328"/>
            <a:ext cx="2843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PBMC Unstained Controls</a:t>
            </a:r>
            <a:endParaRPr lang="en-US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2084832" y="2371190"/>
            <a:ext cx="2843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MSC Unstained Controls</a:t>
            </a:r>
            <a:endParaRPr 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5696712" y="4754880"/>
            <a:ext cx="615391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Figure 1: Unstained controls for MUTZ-3, MSC, and PBMCs.  A.) MUTZ-3 Unstained controls for ROX and GSH.  B.) PBMC Unstained controls for both CD4 and CD8 T cells. C.) Unstained controls for MSC cells. 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21816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60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Ternan, Patrick</dc:creator>
  <cp:lastModifiedBy>McTernan, Patrick</cp:lastModifiedBy>
  <cp:revision>3</cp:revision>
  <dcterms:created xsi:type="dcterms:W3CDTF">2020-05-21T15:38:18Z</dcterms:created>
  <dcterms:modified xsi:type="dcterms:W3CDTF">2020-11-12T20:13:09Z</dcterms:modified>
</cp:coreProperties>
</file>